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74E63D1-170D-4031-BCFF-DF856B7BB8AB}" v="11" dt="2026-04-10T20:38:51.9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0" autoAdjust="0"/>
    <p:restoredTop sz="94660"/>
  </p:normalViewPr>
  <p:slideViewPr>
    <p:cSldViewPr snapToGrid="0">
      <p:cViewPr varScale="1">
        <p:scale>
          <a:sx n="80" d="100"/>
          <a:sy n="80" d="100"/>
        </p:scale>
        <p:origin x="-1496" y="-96"/>
      </p:cViewPr>
      <p:guideLst>
        <p:guide orient="horz" pos="28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microsoft.com/office/2015/10/relationships/revisionInfo" Target="revisionInfo.xml"/><Relationship Id="rId12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wn Holmes" userId="b7a8a953-5552-462e-ab5c-f3e22cb2b5df" providerId="ADAL" clId="{91CB56AA-EA07-4E7B-8CF8-687302C44E3C}"/>
    <pc:docChg chg="custSel addSld modSld">
      <pc:chgData name="Dawn Holmes" userId="b7a8a953-5552-462e-ab5c-f3e22cb2b5df" providerId="ADAL" clId="{91CB56AA-EA07-4E7B-8CF8-687302C44E3C}" dt="2026-04-10T20:45:54.121" v="517" actId="1038"/>
      <pc:docMkLst>
        <pc:docMk/>
      </pc:docMkLst>
      <pc:sldChg chg="addSp modSp mod">
        <pc:chgData name="Dawn Holmes" userId="b7a8a953-5552-462e-ab5c-f3e22cb2b5df" providerId="ADAL" clId="{91CB56AA-EA07-4E7B-8CF8-687302C44E3C}" dt="2026-04-10T20:44:23.863" v="489" actId="408"/>
        <pc:sldMkLst>
          <pc:docMk/>
          <pc:sldMk cId="977115095" sldId="256"/>
        </pc:sldMkLst>
        <pc:spChg chg="add mod">
          <ac:chgData name="Dawn Holmes" userId="b7a8a953-5552-462e-ab5c-f3e22cb2b5df" providerId="ADAL" clId="{91CB56AA-EA07-4E7B-8CF8-687302C44E3C}" dt="2026-04-10T19:40:47.057" v="37" actId="6549"/>
          <ac:spMkLst>
            <pc:docMk/>
            <pc:sldMk cId="977115095" sldId="256"/>
            <ac:spMk id="18" creationId="{7B0E88DD-0C20-AB05-D1BD-9472D98F9171}"/>
          </ac:spMkLst>
        </pc:spChg>
        <pc:grpChg chg="mod">
          <ac:chgData name="Dawn Holmes" userId="b7a8a953-5552-462e-ab5c-f3e22cb2b5df" providerId="ADAL" clId="{91CB56AA-EA07-4E7B-8CF8-687302C44E3C}" dt="2026-04-10T20:44:23.863" v="489" actId="408"/>
          <ac:grpSpMkLst>
            <pc:docMk/>
            <pc:sldMk cId="977115095" sldId="256"/>
            <ac:grpSpMk id="15" creationId="{F0FA55E5-1A27-B56C-3C16-557E92953ADC}"/>
          </ac:grpSpMkLst>
        </pc:grpChg>
        <pc:graphicFrameChg chg="modGraphic">
          <ac:chgData name="Dawn Holmes" userId="b7a8a953-5552-462e-ab5c-f3e22cb2b5df" providerId="ADAL" clId="{91CB56AA-EA07-4E7B-8CF8-687302C44E3C}" dt="2026-04-10T20:28:44.018" v="159" actId="207"/>
          <ac:graphicFrameMkLst>
            <pc:docMk/>
            <pc:sldMk cId="977115095" sldId="256"/>
            <ac:graphicFrameMk id="10" creationId="{E5F25AC9-03FD-2C98-70BA-0FEAC5975D9C}"/>
          </ac:graphicFrameMkLst>
        </pc:graphicFrameChg>
      </pc:sldChg>
      <pc:sldChg chg="addSp delSp modSp new mod">
        <pc:chgData name="Dawn Holmes" userId="b7a8a953-5552-462e-ab5c-f3e22cb2b5df" providerId="ADAL" clId="{91CB56AA-EA07-4E7B-8CF8-687302C44E3C}" dt="2026-04-10T20:44:37.648" v="490" actId="408"/>
        <pc:sldMkLst>
          <pc:docMk/>
          <pc:sldMk cId="2493622640" sldId="257"/>
        </pc:sldMkLst>
        <pc:spChg chg="del">
          <ac:chgData name="Dawn Holmes" userId="b7a8a953-5552-462e-ab5c-f3e22cb2b5df" providerId="ADAL" clId="{91CB56AA-EA07-4E7B-8CF8-687302C44E3C}" dt="2026-04-10T19:40:19.529" v="31" actId="478"/>
          <ac:spMkLst>
            <pc:docMk/>
            <pc:sldMk cId="2493622640" sldId="257"/>
            <ac:spMk id="2" creationId="{A3737E4E-BE2C-5B93-F40E-37E2C511264C}"/>
          </ac:spMkLst>
        </pc:spChg>
        <pc:spChg chg="del">
          <ac:chgData name="Dawn Holmes" userId="b7a8a953-5552-462e-ab5c-f3e22cb2b5df" providerId="ADAL" clId="{91CB56AA-EA07-4E7B-8CF8-687302C44E3C}" dt="2026-04-10T19:40:19.529" v="31" actId="478"/>
          <ac:spMkLst>
            <pc:docMk/>
            <pc:sldMk cId="2493622640" sldId="257"/>
            <ac:spMk id="3" creationId="{6DD9DF37-206C-5EAA-ACAC-12F4EE38E1F6}"/>
          </ac:spMkLst>
        </pc:spChg>
        <pc:spChg chg="add mod">
          <ac:chgData name="Dawn Holmes" userId="b7a8a953-5552-462e-ab5c-f3e22cb2b5df" providerId="ADAL" clId="{91CB56AA-EA07-4E7B-8CF8-687302C44E3C}" dt="2026-04-10T19:40:38.993" v="36" actId="20577"/>
          <ac:spMkLst>
            <pc:docMk/>
            <pc:sldMk cId="2493622640" sldId="257"/>
            <ac:spMk id="4" creationId="{C6901CFC-6C25-4165-5425-D7D6E08DCB0D}"/>
          </ac:spMkLst>
        </pc:spChg>
        <pc:spChg chg="add mod">
          <ac:chgData name="Dawn Holmes" userId="b7a8a953-5552-462e-ab5c-f3e22cb2b5df" providerId="ADAL" clId="{91CB56AA-EA07-4E7B-8CF8-687302C44E3C}" dt="2026-04-10T20:26:43.921" v="117" actId="1037"/>
          <ac:spMkLst>
            <pc:docMk/>
            <pc:sldMk cId="2493622640" sldId="257"/>
            <ac:spMk id="11" creationId="{2B4112E5-CECA-3C0F-165A-690372CC5C8A}"/>
          </ac:spMkLst>
        </pc:spChg>
        <pc:spChg chg="add mod">
          <ac:chgData name="Dawn Holmes" userId="b7a8a953-5552-462e-ab5c-f3e22cb2b5df" providerId="ADAL" clId="{91CB56AA-EA07-4E7B-8CF8-687302C44E3C}" dt="2026-04-10T20:26:58.078" v="131" actId="1038"/>
          <ac:spMkLst>
            <pc:docMk/>
            <pc:sldMk cId="2493622640" sldId="257"/>
            <ac:spMk id="12" creationId="{15130566-8635-6500-2A4F-3A22112A92C2}"/>
          </ac:spMkLst>
        </pc:spChg>
        <pc:spChg chg="add mod">
          <ac:chgData name="Dawn Holmes" userId="b7a8a953-5552-462e-ab5c-f3e22cb2b5df" providerId="ADAL" clId="{91CB56AA-EA07-4E7B-8CF8-687302C44E3C}" dt="2026-04-10T20:27:16.188" v="153" actId="20577"/>
          <ac:spMkLst>
            <pc:docMk/>
            <pc:sldMk cId="2493622640" sldId="257"/>
            <ac:spMk id="13" creationId="{47D48608-7762-F567-560B-31F68B48E3B9}"/>
          </ac:spMkLst>
        </pc:spChg>
        <pc:graphicFrameChg chg="add mod modGraphic">
          <ac:chgData name="Dawn Holmes" userId="b7a8a953-5552-462e-ab5c-f3e22cb2b5df" providerId="ADAL" clId="{91CB56AA-EA07-4E7B-8CF8-687302C44E3C}" dt="2026-04-10T20:29:03.922" v="162" actId="207"/>
          <ac:graphicFrameMkLst>
            <pc:docMk/>
            <pc:sldMk cId="2493622640" sldId="257"/>
            <ac:graphicFrameMk id="14" creationId="{90FBD53C-8FEE-D416-3704-3FF636210609}"/>
          </ac:graphicFrameMkLst>
        </pc:graphicFrameChg>
        <pc:picChg chg="add mod">
          <ac:chgData name="Dawn Holmes" userId="b7a8a953-5552-462e-ab5c-f3e22cb2b5df" providerId="ADAL" clId="{91CB56AA-EA07-4E7B-8CF8-687302C44E3C}" dt="2026-04-10T20:25:59.491" v="72" actId="1036"/>
          <ac:picMkLst>
            <pc:docMk/>
            <pc:sldMk cId="2493622640" sldId="257"/>
            <ac:picMk id="6" creationId="{724142F5-F417-3BC9-3FEB-F01D22458ADF}"/>
          </ac:picMkLst>
        </pc:picChg>
        <pc:picChg chg="add mod">
          <ac:chgData name="Dawn Holmes" userId="b7a8a953-5552-462e-ab5c-f3e22cb2b5df" providerId="ADAL" clId="{91CB56AA-EA07-4E7B-8CF8-687302C44E3C}" dt="2026-04-10T20:26:13.058" v="99" actId="1038"/>
          <ac:picMkLst>
            <pc:docMk/>
            <pc:sldMk cId="2493622640" sldId="257"/>
            <ac:picMk id="8" creationId="{A284A127-C6BF-E1EF-2439-7EFFCFB785F0}"/>
          </ac:picMkLst>
        </pc:picChg>
        <pc:picChg chg="add mod">
          <ac:chgData name="Dawn Holmes" userId="b7a8a953-5552-462e-ab5c-f3e22cb2b5df" providerId="ADAL" clId="{91CB56AA-EA07-4E7B-8CF8-687302C44E3C}" dt="2026-04-10T20:44:37.648" v="490" actId="408"/>
          <ac:picMkLst>
            <pc:docMk/>
            <pc:sldMk cId="2493622640" sldId="257"/>
            <ac:picMk id="10" creationId="{2082C7BD-F2B2-AA35-E09B-F4E0210B6E37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20:45:34.824" v="505" actId="1035"/>
        <pc:sldMkLst>
          <pc:docMk/>
          <pc:sldMk cId="1029559597" sldId="258"/>
        </pc:sldMkLst>
        <pc:spChg chg="del">
          <ac:chgData name="Dawn Holmes" userId="b7a8a953-5552-462e-ab5c-f3e22cb2b5df" providerId="ADAL" clId="{91CB56AA-EA07-4E7B-8CF8-687302C44E3C}" dt="2026-04-10T20:29:15.569" v="164" actId="478"/>
          <ac:spMkLst>
            <pc:docMk/>
            <pc:sldMk cId="1029559597" sldId="258"/>
            <ac:spMk id="2" creationId="{84597591-ECD1-97D3-F380-B94024D27AFB}"/>
          </ac:spMkLst>
        </pc:spChg>
        <pc:spChg chg="del">
          <ac:chgData name="Dawn Holmes" userId="b7a8a953-5552-462e-ab5c-f3e22cb2b5df" providerId="ADAL" clId="{91CB56AA-EA07-4E7B-8CF8-687302C44E3C}" dt="2026-04-10T20:29:15.569" v="164" actId="478"/>
          <ac:spMkLst>
            <pc:docMk/>
            <pc:sldMk cId="1029559597" sldId="258"/>
            <ac:spMk id="3" creationId="{B7318C0E-6E46-7CC1-7FA6-646813619632}"/>
          </ac:spMkLst>
        </pc:spChg>
        <pc:spChg chg="add mod">
          <ac:chgData name="Dawn Holmes" userId="b7a8a953-5552-462e-ab5c-f3e22cb2b5df" providerId="ADAL" clId="{91CB56AA-EA07-4E7B-8CF8-687302C44E3C}" dt="2026-04-10T20:45:34.824" v="505" actId="1035"/>
          <ac:spMkLst>
            <pc:docMk/>
            <pc:sldMk cId="1029559597" sldId="258"/>
            <ac:spMk id="10" creationId="{15A307BA-C420-3139-C211-93B92260A791}"/>
          </ac:spMkLst>
        </pc:spChg>
        <pc:spChg chg="add mod">
          <ac:chgData name="Dawn Holmes" userId="b7a8a953-5552-462e-ab5c-f3e22cb2b5df" providerId="ADAL" clId="{91CB56AA-EA07-4E7B-8CF8-687302C44E3C}" dt="2026-04-10T20:45:32.074" v="503" actId="1035"/>
          <ac:spMkLst>
            <pc:docMk/>
            <pc:sldMk cId="1029559597" sldId="258"/>
            <ac:spMk id="11" creationId="{FA357E87-E01B-D2E0-E3FF-F149E832F668}"/>
          </ac:spMkLst>
        </pc:spChg>
        <pc:spChg chg="add mod">
          <ac:chgData name="Dawn Holmes" userId="b7a8a953-5552-462e-ab5c-f3e22cb2b5df" providerId="ADAL" clId="{91CB56AA-EA07-4E7B-8CF8-687302C44E3C}" dt="2026-04-10T20:45:27.741" v="499" actId="1035"/>
          <ac:spMkLst>
            <pc:docMk/>
            <pc:sldMk cId="1029559597" sldId="258"/>
            <ac:spMk id="12" creationId="{0CE6339E-74C5-F680-A77C-27D1DF43A977}"/>
          </ac:spMkLst>
        </pc:spChg>
        <pc:spChg chg="add mod">
          <ac:chgData name="Dawn Holmes" userId="b7a8a953-5552-462e-ab5c-f3e22cb2b5df" providerId="ADAL" clId="{91CB56AA-EA07-4E7B-8CF8-687302C44E3C}" dt="2026-04-10T20:33:41.637" v="274" actId="6549"/>
          <ac:spMkLst>
            <pc:docMk/>
            <pc:sldMk cId="1029559597" sldId="258"/>
            <ac:spMk id="14" creationId="{92366D2D-B903-53A5-5521-7971B87801BE}"/>
          </ac:spMkLst>
        </pc:spChg>
        <pc:graphicFrameChg chg="add mod modGraphic">
          <ac:chgData name="Dawn Holmes" userId="b7a8a953-5552-462e-ab5c-f3e22cb2b5df" providerId="ADAL" clId="{91CB56AA-EA07-4E7B-8CF8-687302C44E3C}" dt="2026-04-10T20:34:07.913" v="277" actId="207"/>
          <ac:graphicFrameMkLst>
            <pc:docMk/>
            <pc:sldMk cId="1029559597" sldId="258"/>
            <ac:graphicFrameMk id="13" creationId="{71E2EFFC-B6C3-A371-FED7-453726AE7F26}"/>
          </ac:graphicFrameMkLst>
        </pc:graphicFrameChg>
        <pc:picChg chg="add mod">
          <ac:chgData name="Dawn Holmes" userId="b7a8a953-5552-462e-ab5c-f3e22cb2b5df" providerId="ADAL" clId="{91CB56AA-EA07-4E7B-8CF8-687302C44E3C}" dt="2026-04-10T20:45:14.278" v="493" actId="554"/>
          <ac:picMkLst>
            <pc:docMk/>
            <pc:sldMk cId="1029559597" sldId="258"/>
            <ac:picMk id="5" creationId="{9EA0D995-9AF8-E190-B697-6F32781A8459}"/>
          </ac:picMkLst>
        </pc:picChg>
        <pc:picChg chg="add mod">
          <ac:chgData name="Dawn Holmes" userId="b7a8a953-5552-462e-ab5c-f3e22cb2b5df" providerId="ADAL" clId="{91CB56AA-EA07-4E7B-8CF8-687302C44E3C}" dt="2026-04-10T20:45:21.440" v="494" actId="408"/>
          <ac:picMkLst>
            <pc:docMk/>
            <pc:sldMk cId="1029559597" sldId="258"/>
            <ac:picMk id="7" creationId="{82D50413-56D2-1A64-FF2C-657A1B41A012}"/>
          </ac:picMkLst>
        </pc:picChg>
        <pc:picChg chg="add mod">
          <ac:chgData name="Dawn Holmes" userId="b7a8a953-5552-462e-ab5c-f3e22cb2b5df" providerId="ADAL" clId="{91CB56AA-EA07-4E7B-8CF8-687302C44E3C}" dt="2026-04-10T20:45:14.278" v="493" actId="554"/>
          <ac:picMkLst>
            <pc:docMk/>
            <pc:sldMk cId="1029559597" sldId="258"/>
            <ac:picMk id="9" creationId="{098D8AB4-F3E9-EC60-DE09-F9B3609BBCFC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20:45:54.121" v="517" actId="1038"/>
        <pc:sldMkLst>
          <pc:docMk/>
          <pc:sldMk cId="3950031444" sldId="259"/>
        </pc:sldMkLst>
        <pc:spChg chg="del">
          <ac:chgData name="Dawn Holmes" userId="b7a8a953-5552-462e-ab5c-f3e22cb2b5df" providerId="ADAL" clId="{91CB56AA-EA07-4E7B-8CF8-687302C44E3C}" dt="2026-04-10T20:34:18.250" v="279" actId="478"/>
          <ac:spMkLst>
            <pc:docMk/>
            <pc:sldMk cId="3950031444" sldId="259"/>
            <ac:spMk id="2" creationId="{2DD5D8F7-DE64-52A9-E476-3707F275E9E4}"/>
          </ac:spMkLst>
        </pc:spChg>
        <pc:spChg chg="del">
          <ac:chgData name="Dawn Holmes" userId="b7a8a953-5552-462e-ab5c-f3e22cb2b5df" providerId="ADAL" clId="{91CB56AA-EA07-4E7B-8CF8-687302C44E3C}" dt="2026-04-10T20:34:18.250" v="279" actId="478"/>
          <ac:spMkLst>
            <pc:docMk/>
            <pc:sldMk cId="3950031444" sldId="259"/>
            <ac:spMk id="3" creationId="{2EE5F71C-9541-1303-3D31-F95EFEEB425F}"/>
          </ac:spMkLst>
        </pc:spChg>
        <pc:spChg chg="add mod">
          <ac:chgData name="Dawn Holmes" userId="b7a8a953-5552-462e-ab5c-f3e22cb2b5df" providerId="ADAL" clId="{91CB56AA-EA07-4E7B-8CF8-687302C44E3C}" dt="2026-04-10T20:36:36.521" v="415" actId="20577"/>
          <ac:spMkLst>
            <pc:docMk/>
            <pc:sldMk cId="3950031444" sldId="259"/>
            <ac:spMk id="10" creationId="{2F020B53-71D8-4687-636B-0E58E80C2C5B}"/>
          </ac:spMkLst>
        </pc:spChg>
        <pc:spChg chg="add mod">
          <ac:chgData name="Dawn Holmes" userId="b7a8a953-5552-462e-ab5c-f3e22cb2b5df" providerId="ADAL" clId="{91CB56AA-EA07-4E7B-8CF8-687302C44E3C}" dt="2026-04-10T20:45:54.121" v="517" actId="1038"/>
          <ac:spMkLst>
            <pc:docMk/>
            <pc:sldMk cId="3950031444" sldId="259"/>
            <ac:spMk id="11" creationId="{4BF5B48E-2CFB-6CD1-4DAC-23C71409B8AE}"/>
          </ac:spMkLst>
        </pc:spChg>
        <pc:spChg chg="add mod">
          <ac:chgData name="Dawn Holmes" userId="b7a8a953-5552-462e-ab5c-f3e22cb2b5df" providerId="ADAL" clId="{91CB56AA-EA07-4E7B-8CF8-687302C44E3C}" dt="2026-04-10T20:37:09.941" v="477" actId="20577"/>
          <ac:spMkLst>
            <pc:docMk/>
            <pc:sldMk cId="3950031444" sldId="259"/>
            <ac:spMk id="12" creationId="{6541CDCD-360F-6B68-EF8B-29EAEBD02D24}"/>
          </ac:spMkLst>
        </pc:spChg>
        <pc:spChg chg="add mod">
          <ac:chgData name="Dawn Holmes" userId="b7a8a953-5552-462e-ab5c-f3e22cb2b5df" providerId="ADAL" clId="{91CB56AA-EA07-4E7B-8CF8-687302C44E3C}" dt="2026-04-10T20:39:06.912" v="488" actId="1076"/>
          <ac:spMkLst>
            <pc:docMk/>
            <pc:sldMk cId="3950031444" sldId="259"/>
            <ac:spMk id="14" creationId="{499902E3-BC12-0846-F668-35E82AA7DA1D}"/>
          </ac:spMkLst>
        </pc:spChg>
        <pc:graphicFrameChg chg="add mod modGraphic">
          <ac:chgData name="Dawn Holmes" userId="b7a8a953-5552-462e-ab5c-f3e22cb2b5df" providerId="ADAL" clId="{91CB56AA-EA07-4E7B-8CF8-687302C44E3C}" dt="2026-04-10T20:38:44.666" v="482" actId="207"/>
          <ac:graphicFrameMkLst>
            <pc:docMk/>
            <pc:sldMk cId="3950031444" sldId="259"/>
            <ac:graphicFrameMk id="13" creationId="{4F5A41F5-1FF0-4F30-7B01-BA12EC7BF5E9}"/>
          </ac:graphicFrameMkLst>
        </pc:graphicFrameChg>
        <pc:picChg chg="add mod">
          <ac:chgData name="Dawn Holmes" userId="b7a8a953-5552-462e-ab5c-f3e22cb2b5df" providerId="ADAL" clId="{91CB56AA-EA07-4E7B-8CF8-687302C44E3C}" dt="2026-04-10T20:36:32.760" v="413" actId="1036"/>
          <ac:picMkLst>
            <pc:docMk/>
            <pc:sldMk cId="3950031444" sldId="259"/>
            <ac:picMk id="5" creationId="{DD03B851-2724-49E2-BE41-D8BE83CEAA94}"/>
          </ac:picMkLst>
        </pc:picChg>
        <pc:picChg chg="add mod">
          <ac:chgData name="Dawn Holmes" userId="b7a8a953-5552-462e-ab5c-f3e22cb2b5df" providerId="ADAL" clId="{91CB56AA-EA07-4E7B-8CF8-687302C44E3C}" dt="2026-04-10T20:37:03.519" v="475" actId="1036"/>
          <ac:picMkLst>
            <pc:docMk/>
            <pc:sldMk cId="3950031444" sldId="259"/>
            <ac:picMk id="7" creationId="{5BD4E072-7193-89E3-8752-4D05F5080F77}"/>
          </ac:picMkLst>
        </pc:picChg>
        <pc:picChg chg="add mod">
          <ac:chgData name="Dawn Holmes" userId="b7a8a953-5552-462e-ab5c-f3e22cb2b5df" providerId="ADAL" clId="{91CB56AA-EA07-4E7B-8CF8-687302C44E3C}" dt="2026-04-10T20:45:46.608" v="506" actId="408"/>
          <ac:picMkLst>
            <pc:docMk/>
            <pc:sldMk cId="3950031444" sldId="259"/>
            <ac:picMk id="9" creationId="{F53DEFA4-CF85-974B-EF5F-2032D7311D6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005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46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26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392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184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773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491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724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185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524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985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BCF3517-E58A-44D9-A975-E33325F12607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5241C0-5D66-44B3-9FD6-0D72DA78D1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00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t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4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4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4" Type="http://schemas.openxmlformats.org/officeDocument/2006/relationships/image" Target="../media/image12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xmlns="" id="{E5F25AC9-03FD-2C98-70BA-0FEAC5975D9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0836551"/>
              </p:ext>
            </p:extLst>
          </p:nvPr>
        </p:nvGraphicFramePr>
        <p:xfrm>
          <a:off x="1325123" y="3490913"/>
          <a:ext cx="9084551" cy="36966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31401">
                  <a:extLst>
                    <a:ext uri="{9D8B030D-6E8A-4147-A177-3AD203B41FA5}">
                      <a16:colId xmlns:a16="http://schemas.microsoft.com/office/drawing/2014/main" xmlns="" val="3713672413"/>
                    </a:ext>
                  </a:extLst>
                </a:gridCol>
                <a:gridCol w="6153150">
                  <a:extLst>
                    <a:ext uri="{9D8B030D-6E8A-4147-A177-3AD203B41FA5}">
                      <a16:colId xmlns:a16="http://schemas.microsoft.com/office/drawing/2014/main" xmlns="" val="2907295212"/>
                    </a:ext>
                  </a:extLst>
                </a:gridCol>
              </a:tblGrid>
              <a:tr h="226795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CoxA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8421669"/>
                  </a:ext>
                </a:extLst>
              </a:tr>
              <a:tr h="2369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6.1%, LT=96.1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08091334"/>
                  </a:ext>
                </a:extLst>
              </a:tr>
              <a:tr h="2090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1.2 Å, TM-score=0.99, MaxSub-score=0.97, GDT-TS-score=0.98, GDT-HA-score=0.96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75348041"/>
                  </a:ext>
                </a:extLst>
              </a:tr>
              <a:tr h="2763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 Å (across all 541 pairs), 0.3 Å (across 528 pruned pairs), 2.4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99624691"/>
                  </a:ext>
                </a:extLst>
              </a:tr>
              <a:tr h="21028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68.95%, LT=69.1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123558"/>
                  </a:ext>
                </a:extLst>
              </a:tr>
              <a:tr h="22044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7.21%, LT=7.02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19815363"/>
                  </a:ext>
                </a:extLst>
              </a:tr>
              <a:tr h="2496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% (6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67580571"/>
                  </a:ext>
                </a:extLst>
              </a:tr>
              <a:tr h="24076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2, df = 1, p-value =0.6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76369232"/>
                  </a:ext>
                </a:extLst>
              </a:tr>
              <a:tr h="21282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, df = 1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28227072"/>
                  </a:ext>
                </a:extLst>
              </a:tr>
              <a:tr h="29918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8.65 Å, LT=20.78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11365750"/>
                  </a:ext>
                </a:extLst>
              </a:tr>
              <a:tr h="25219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97, df = 17, p-value =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45691475"/>
                  </a:ext>
                </a:extLst>
              </a:tr>
              <a:tr h="2814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18 Å, LT=1.19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422022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NaN, df = 31, p-value = 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3643237"/>
                  </a:ext>
                </a:extLst>
              </a:tr>
            </a:tbl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72FD83F-9D65-3191-FD2E-D5F3744865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162" y="264284"/>
            <a:ext cx="3016799" cy="292748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FDA6BF4-7639-DFFF-B395-662745A7DFB8}"/>
              </a:ext>
            </a:extLst>
          </p:cNvPr>
          <p:cNvSpPr txBox="1"/>
          <p:nvPr/>
        </p:nvSpPr>
        <p:spPr>
          <a:xfrm>
            <a:off x="2686881" y="221729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A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D13C70EB-08C5-4B26-AA17-0C83232503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0738" y="212649"/>
            <a:ext cx="3016799" cy="29440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AFF999C4-8B0E-9C69-262D-9F0476321FE9}"/>
              </a:ext>
            </a:extLst>
          </p:cNvPr>
          <p:cNvSpPr txBox="1"/>
          <p:nvPr/>
        </p:nvSpPr>
        <p:spPr>
          <a:xfrm>
            <a:off x="6543186" y="252169"/>
            <a:ext cx="1076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A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9C2A5A0C-CF22-E162-8181-4CB02822393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6039" y="247488"/>
            <a:ext cx="3016799" cy="29442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59BA8AF4-DF7B-0866-2453-1B029DD7C96D}"/>
              </a:ext>
            </a:extLst>
          </p:cNvPr>
          <p:cNvSpPr txBox="1"/>
          <p:nvPr/>
        </p:nvSpPr>
        <p:spPr>
          <a:xfrm>
            <a:off x="9659132" y="244399"/>
            <a:ext cx="1614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A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7B0E88DD-0C20-AB05-D1BD-9472D98F9171}"/>
              </a:ext>
            </a:extLst>
          </p:cNvPr>
          <p:cNvSpPr txBox="1"/>
          <p:nvPr/>
        </p:nvSpPr>
        <p:spPr>
          <a:xfrm>
            <a:off x="287724" y="7528725"/>
            <a:ext cx="1098511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Figure S5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(A) Tertiary structure predictions made from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xA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The structures were visualized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For structural comparisons, the predicted structures were superimposed using Matchmaker and colored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y calculated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er residue 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DejaVu Sans"/>
              </a:rPr>
              <a:t>α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-RMSD. Residues are colored on a continuous gradient: Blue indicates the highest similarity (RM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were also analyzed in DSSP and statistics comparing DSSP results were done with the R-stats packag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77115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C6901CFC-6C25-4165-5425-D7D6E08DCB0D}"/>
              </a:ext>
            </a:extLst>
          </p:cNvPr>
          <p:cNvSpPr txBox="1"/>
          <p:nvPr/>
        </p:nvSpPr>
        <p:spPr>
          <a:xfrm>
            <a:off x="287724" y="7528725"/>
            <a:ext cx="1098511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Figure S5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(B) Tertiary structure predictions made from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xB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The structures were visualized and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ositions were label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Heme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localizations in the individual proteins are highlighted in purple. For structural comparisons, the predicted structures were superimposed using Matchmaker and colored by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alculated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per residue 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DejaVu Sans"/>
              </a:rPr>
              <a:t>α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-RMSD. Residues are colored on a continuous gradient: Blue indicates the highest similarity (RM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were also analyzed in DSSP and statistics comparing DSSP results were done with the R-stats package.</a:t>
            </a:r>
            <a:endParaRPr lang="en-US" sz="12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724142F5-F417-3BC9-3FEB-F01D22458A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024" y="243799"/>
            <a:ext cx="3639585" cy="26105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A284A127-C6BF-E1EF-2439-7EFFCFB785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0209" y="237298"/>
            <a:ext cx="3639585" cy="26105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2082C7BD-F2B2-AA35-E09B-F4E0210B6E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4616" y="237297"/>
            <a:ext cx="3639585" cy="26170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B4112E5-CECA-3C0F-165A-690372CC5C8A}"/>
              </a:ext>
            </a:extLst>
          </p:cNvPr>
          <p:cNvSpPr txBox="1"/>
          <p:nvPr/>
        </p:nvSpPr>
        <p:spPr>
          <a:xfrm>
            <a:off x="182360" y="2491854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B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15130566-8635-6500-2A4F-3A22112A92C2}"/>
              </a:ext>
            </a:extLst>
          </p:cNvPr>
          <p:cNvSpPr txBox="1"/>
          <p:nvPr/>
        </p:nvSpPr>
        <p:spPr>
          <a:xfrm>
            <a:off x="4150006" y="2466299"/>
            <a:ext cx="1076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B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7D48608-7762-F567-560B-31F68B48E3B9}"/>
              </a:ext>
            </a:extLst>
          </p:cNvPr>
          <p:cNvSpPr txBox="1"/>
          <p:nvPr/>
        </p:nvSpPr>
        <p:spPr>
          <a:xfrm>
            <a:off x="8143965" y="2466899"/>
            <a:ext cx="1614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B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xmlns="" id="{90FBD53C-8FEE-D416-3704-3FF6362106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2687244"/>
              </p:ext>
            </p:extLst>
          </p:nvPr>
        </p:nvGraphicFramePr>
        <p:xfrm>
          <a:off x="827889" y="3189012"/>
          <a:ext cx="9427451" cy="370552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83801">
                  <a:extLst>
                    <a:ext uri="{9D8B030D-6E8A-4147-A177-3AD203B41FA5}">
                      <a16:colId xmlns:a16="http://schemas.microsoft.com/office/drawing/2014/main" xmlns="" val="3628959747"/>
                    </a:ext>
                  </a:extLst>
                </a:gridCol>
                <a:gridCol w="6343650">
                  <a:extLst>
                    <a:ext uri="{9D8B030D-6E8A-4147-A177-3AD203B41FA5}">
                      <a16:colId xmlns:a16="http://schemas.microsoft.com/office/drawing/2014/main" xmlns="" val="1200901900"/>
                    </a:ext>
                  </a:extLst>
                </a:gridCol>
              </a:tblGrid>
              <a:tr h="207745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CoxB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36212867"/>
                  </a:ext>
                </a:extLst>
              </a:tr>
              <a:tr h="1988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6.2%, LT=94.1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6719473"/>
                  </a:ext>
                </a:extLst>
              </a:tr>
              <a:tr h="22806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19.61 Å, TM-score=0.16, MaxSub-score=0.06, GDT-TS-score=0.08, GDT-HA-score=0.06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73710989"/>
                  </a:ext>
                </a:extLst>
              </a:tr>
              <a:tr h="2382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 Å (across all 288 pairs), 1.12 Å (across 272 pruned pairs), 5.6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34413397"/>
                  </a:ext>
                </a:extLst>
              </a:tr>
              <a:tr h="22933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8.2%, LT=38.8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12717693"/>
                  </a:ext>
                </a:extLst>
              </a:tr>
              <a:tr h="29664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0.6%, LT=28.6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14606657"/>
                  </a:ext>
                </a:extLst>
              </a:tr>
              <a:tr h="1925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7% (31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71539857"/>
                  </a:ext>
                </a:extLst>
              </a:tr>
              <a:tr h="27886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3.2, df = 1, p-value =0.0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09882780"/>
                  </a:ext>
                </a:extLst>
              </a:tr>
              <a:tr h="25092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14, df = 1, p-value = 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09271600"/>
                  </a:ext>
                </a:extLst>
              </a:tr>
              <a:tr h="22298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0 Å, LT=10.7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28296974"/>
                  </a:ext>
                </a:extLst>
              </a:tr>
              <a:tr h="29029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.07, df = 23, p-value =0.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05485122"/>
                  </a:ext>
                </a:extLst>
              </a:tr>
              <a:tr h="2433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.67 Å, LT=3.6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10120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54, df = 10, p-value = 0.6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436705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936226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9EA0D995-9AF8-E190-B697-6F32781A84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724" y="198784"/>
            <a:ext cx="3616601" cy="2714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82D50413-56D2-1A64-FF2C-657A1B41A0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7066" y="198784"/>
            <a:ext cx="3616601" cy="2714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098D8AB4-F3E9-EC60-DE09-F9B3609BBC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6408" y="198784"/>
            <a:ext cx="3581400" cy="27883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15A307BA-C420-3139-C211-93B92260A791}"/>
              </a:ext>
            </a:extLst>
          </p:cNvPr>
          <p:cNvSpPr txBox="1"/>
          <p:nvPr/>
        </p:nvSpPr>
        <p:spPr>
          <a:xfrm>
            <a:off x="275534" y="156254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C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FA357E87-E01B-D2E0-E3FF-F149E832F668}"/>
              </a:ext>
            </a:extLst>
          </p:cNvPr>
          <p:cNvSpPr txBox="1"/>
          <p:nvPr/>
        </p:nvSpPr>
        <p:spPr>
          <a:xfrm>
            <a:off x="4282383" y="167544"/>
            <a:ext cx="1089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C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0CE6339E-74C5-F680-A77C-27D1DF43A977}"/>
              </a:ext>
            </a:extLst>
          </p:cNvPr>
          <p:cNvSpPr txBox="1"/>
          <p:nvPr/>
        </p:nvSpPr>
        <p:spPr>
          <a:xfrm>
            <a:off x="8162178" y="139010"/>
            <a:ext cx="1627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C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71E2EFFC-B6C3-A371-FED7-453726AE7F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960380"/>
              </p:ext>
            </p:extLst>
          </p:nvPr>
        </p:nvGraphicFramePr>
        <p:xfrm>
          <a:off x="1355035" y="3288403"/>
          <a:ext cx="9008351" cy="367865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31401">
                  <a:extLst>
                    <a:ext uri="{9D8B030D-6E8A-4147-A177-3AD203B41FA5}">
                      <a16:colId xmlns:a16="http://schemas.microsoft.com/office/drawing/2014/main" xmlns="" val="1121749858"/>
                    </a:ext>
                  </a:extLst>
                </a:gridCol>
                <a:gridCol w="6076950">
                  <a:extLst>
                    <a:ext uri="{9D8B030D-6E8A-4147-A177-3AD203B41FA5}">
                      <a16:colId xmlns:a16="http://schemas.microsoft.com/office/drawing/2014/main" xmlns="" val="3781478810"/>
                    </a:ext>
                  </a:extLst>
                </a:gridCol>
              </a:tblGrid>
              <a:tr h="245845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CoxC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71947789"/>
                  </a:ext>
                </a:extLst>
              </a:tr>
              <a:tr h="2369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6%, LT=96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63005628"/>
                  </a:ext>
                </a:extLst>
              </a:tr>
              <a:tr h="2090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19 Å, TM-score=0.99, MaxSub-score=0.99, GDT-TS-score=1, GDT-HA-score=0.9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91585389"/>
                  </a:ext>
                </a:extLst>
              </a:tr>
              <a:tr h="2191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 Å (across all 200 pairs), 0.19 Å (across 200 pruned pairs), 5.5% of protein deviates &gt;0.5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8313205"/>
                  </a:ext>
                </a:extLst>
              </a:tr>
              <a:tr h="19123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82.5%, LT=82.5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48400822"/>
                  </a:ext>
                </a:extLst>
              </a:tr>
              <a:tr h="22044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0%, LT=9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01815224"/>
                  </a:ext>
                </a:extLst>
              </a:tr>
              <a:tr h="2306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 ( 2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90514085"/>
                  </a:ext>
                </a:extLst>
              </a:tr>
              <a:tr h="2217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, df = 1, p-value =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30707902"/>
                  </a:ext>
                </a:extLst>
              </a:tr>
              <a:tr h="26997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, df = 1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50517790"/>
                  </a:ext>
                </a:extLst>
              </a:tr>
              <a:tr h="22298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3.57 Å, LT=23.57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97275341"/>
                  </a:ext>
                </a:extLst>
              </a:tr>
              <a:tr h="29029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6, p-value =2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96903667"/>
                  </a:ext>
                </a:extLst>
              </a:tr>
              <a:tr h="2623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11 Å, LT=1.1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088728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7, p-value = 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91256907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92366D2D-B903-53A5-5521-7971B87801BE}"/>
              </a:ext>
            </a:extLst>
          </p:cNvPr>
          <p:cNvSpPr txBox="1"/>
          <p:nvPr/>
        </p:nvSpPr>
        <p:spPr>
          <a:xfrm>
            <a:off x="287724" y="7528725"/>
            <a:ext cx="1098511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Figure S5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(C) Tertiary structure predictions made from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x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The structures were visualized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For structural comparisons, the predicted structures were superimposed using Matchmaker and colored by the calculated per residue 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DejaVu Sans"/>
              </a:rPr>
              <a:t>α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-RMSD. Residues are colored on a continuous gradient: Blue indicates the highest similarity (RM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were also analyzed in DSSP and statistics comparing DSSP results were done with the R-stats packag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29559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DD03B851-2724-49E2-BE41-D8BE83CEAA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844" y="215764"/>
            <a:ext cx="3737172" cy="20521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5BD4E072-7193-89E3-8752-4D05F5080F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1762" y="218144"/>
            <a:ext cx="3737172" cy="20521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F53DEFA4-CF85-974B-EF5F-2032D7311D6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8303" y="197648"/>
            <a:ext cx="3737172" cy="20206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2F020B53-71D8-4687-636B-0E58E80C2C5B}"/>
              </a:ext>
            </a:extLst>
          </p:cNvPr>
          <p:cNvSpPr txBox="1"/>
          <p:nvPr/>
        </p:nvSpPr>
        <p:spPr>
          <a:xfrm>
            <a:off x="196159" y="232641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D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4BF5B48E-2CFB-6CD1-4DAC-23C71409B8AE}"/>
              </a:ext>
            </a:extLst>
          </p:cNvPr>
          <p:cNvSpPr txBox="1"/>
          <p:nvPr/>
        </p:nvSpPr>
        <p:spPr>
          <a:xfrm>
            <a:off x="4213198" y="220557"/>
            <a:ext cx="1089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D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6541CDCD-360F-6B68-EF8B-29EAEBD02D24}"/>
              </a:ext>
            </a:extLst>
          </p:cNvPr>
          <p:cNvSpPr txBox="1"/>
          <p:nvPr/>
        </p:nvSpPr>
        <p:spPr>
          <a:xfrm>
            <a:off x="8193928" y="244268"/>
            <a:ext cx="1627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CoxD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4F5A41F5-1FF0-4F30-7B01-BA12EC7BF5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8410004"/>
              </p:ext>
            </p:extLst>
          </p:nvPr>
        </p:nvGraphicFramePr>
        <p:xfrm>
          <a:off x="929545" y="2476500"/>
          <a:ext cx="10182955" cy="366341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53580">
                  <a:extLst>
                    <a:ext uri="{9D8B030D-6E8A-4147-A177-3AD203B41FA5}">
                      <a16:colId xmlns:a16="http://schemas.microsoft.com/office/drawing/2014/main" xmlns="" val="876656258"/>
                    </a:ext>
                  </a:extLst>
                </a:gridCol>
                <a:gridCol w="6429375">
                  <a:extLst>
                    <a:ext uri="{9D8B030D-6E8A-4147-A177-3AD203B41FA5}">
                      <a16:colId xmlns:a16="http://schemas.microsoft.com/office/drawing/2014/main" xmlns="" val="1624806956"/>
                    </a:ext>
                  </a:extLst>
                </a:gridCol>
              </a:tblGrid>
              <a:tr h="266383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Cox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08704296"/>
                  </a:ext>
                </a:extLst>
              </a:tr>
              <a:tr h="2750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6.2%, LT=94.1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43090241"/>
                  </a:ext>
                </a:extLst>
              </a:tr>
              <a:tr h="1607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7 Å, TM-score=0.96, MaxSub-score=0.96, GDT-TS-score=0.98, GDT-HA-score=0.9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14722625"/>
                  </a:ext>
                </a:extLst>
              </a:tr>
              <a:tr h="2090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 Å (across all 96 pairs), 0.33 Å (across 91 pruned pairs), 5.2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08485998"/>
                  </a:ext>
                </a:extLst>
              </a:tr>
              <a:tr h="2001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73.96%, LT=71.88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11714679"/>
                  </a:ext>
                </a:extLst>
              </a:tr>
              <a:tr h="22933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5.21%, LT=5.2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09840819"/>
                  </a:ext>
                </a:extLst>
              </a:tr>
              <a:tr h="25854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% (2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28351737"/>
                  </a:ext>
                </a:extLst>
              </a:tr>
              <a:tr h="2687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2, df = 1, p-value =0.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82633241"/>
                  </a:ext>
                </a:extLst>
              </a:tr>
              <a:tr h="24076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, df = 1, p-value = 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20728205"/>
                  </a:ext>
                </a:extLst>
              </a:tr>
              <a:tr h="2699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3.67 Å, LT=2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93626216"/>
                  </a:ext>
                </a:extLst>
              </a:tr>
              <a:tr h="24203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1, df = 2, p-value =0.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53855683"/>
                  </a:ext>
                </a:extLst>
              </a:tr>
              <a:tr h="23314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 Å, LT=1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476563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N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4, p-value = 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25598901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499902E3-BC12-0846-F668-35E82AA7DA1D}"/>
              </a:ext>
            </a:extLst>
          </p:cNvPr>
          <p:cNvSpPr txBox="1"/>
          <p:nvPr/>
        </p:nvSpPr>
        <p:spPr>
          <a:xfrm>
            <a:off x="881880" y="6414020"/>
            <a:ext cx="1098511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Supplementary Figure S5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(D) Tertiary structure predictions made from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x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proteins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The structures were visualized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. For structural comparisons, the predicted structures were superimposed using Matchmaker and colored by the calculated per residue 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DejaVu Sans"/>
              </a:rPr>
              <a:t>α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-RMSD. Residues are colored on a continuous gradient: Blue indicates the highest similarity (RM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2 A). Secondary structures predicted by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were also analyzed in DSSP and statistics comparing DSSP results were done with the R-stats packag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50031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</TotalTime>
  <Words>1377</Words>
  <Application>Microsoft Macintosh PowerPoint</Application>
  <PresentationFormat>Custom</PresentationFormat>
  <Paragraphs>120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Western New Englan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wn Holmes</dc:creator>
  <cp:lastModifiedBy>Dawn Holmes</cp:lastModifiedBy>
  <cp:revision>3</cp:revision>
  <dcterms:created xsi:type="dcterms:W3CDTF">2026-04-10T19:23:42Z</dcterms:created>
  <dcterms:modified xsi:type="dcterms:W3CDTF">2026-04-11T16:46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cc4f9dd6-a4b8-4763-a61d-db8d0cf51108_Enabled">
    <vt:lpwstr>true</vt:lpwstr>
  </property>
  <property fmtid="{D5CDD505-2E9C-101B-9397-08002B2CF9AE}" pid="3" name="MSIP_Label_cc4f9dd6-a4b8-4763-a61d-db8d0cf51108_SetDate">
    <vt:lpwstr>2026-04-10T19:38:25Z</vt:lpwstr>
  </property>
  <property fmtid="{D5CDD505-2E9C-101B-9397-08002B2CF9AE}" pid="4" name="MSIP_Label_cc4f9dd6-a4b8-4763-a61d-db8d0cf51108_Method">
    <vt:lpwstr>Standard</vt:lpwstr>
  </property>
  <property fmtid="{D5CDD505-2E9C-101B-9397-08002B2CF9AE}" pid="5" name="MSIP_Label_cc4f9dd6-a4b8-4763-a61d-db8d0cf51108_Name">
    <vt:lpwstr>defa4170-0d19-0005-0004-bc88714345d2</vt:lpwstr>
  </property>
  <property fmtid="{D5CDD505-2E9C-101B-9397-08002B2CF9AE}" pid="6" name="MSIP_Label_cc4f9dd6-a4b8-4763-a61d-db8d0cf51108_SiteId">
    <vt:lpwstr>b5a5796f-19a9-493f-9cb2-7a88b4e9b123</vt:lpwstr>
  </property>
  <property fmtid="{D5CDD505-2E9C-101B-9397-08002B2CF9AE}" pid="7" name="MSIP_Label_cc4f9dd6-a4b8-4763-a61d-db8d0cf51108_ActionId">
    <vt:lpwstr>986b5496-b708-4408-9d2d-3ec53fb85197</vt:lpwstr>
  </property>
  <property fmtid="{D5CDD505-2E9C-101B-9397-08002B2CF9AE}" pid="8" name="MSIP_Label_cc4f9dd6-a4b8-4763-a61d-db8d0cf51108_ContentBits">
    <vt:lpwstr>0</vt:lpwstr>
  </property>
  <property fmtid="{D5CDD505-2E9C-101B-9397-08002B2CF9AE}" pid="9" name="MSIP_Label_cc4f9dd6-a4b8-4763-a61d-db8d0cf51108_Tag">
    <vt:lpwstr>10, 3, 0, 1</vt:lpwstr>
  </property>
</Properties>
</file>